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92" r:id="rId2"/>
    <p:sldId id="284" r:id="rId3"/>
    <p:sldId id="293" r:id="rId4"/>
    <p:sldId id="294" r:id="rId5"/>
    <p:sldId id="260" r:id="rId6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4056" userDrawn="1">
          <p15:clr>
            <a:srgbClr val="A4A3A4"/>
          </p15:clr>
        </p15:guide>
        <p15:guide id="2" pos="189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  <p:ext uri="http://customooxmlschemas.google.com/">
      <go:slidesCustomData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xmlns="" r:id="rId23" roundtripDataSignature="AMtx7mjSdZX3mKunu+7VLCRvjyv4oTOFG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0592C65-0FFA-E320-2E27-ACA7792058B7}" name="Rita Adubeiro Lourenco" initials="" userId="S::rad.lourenco@FCT.UNL.PT::172cfa0c-bd64-44c3-9a37-0c17c40783e1" providerId="AD"/>
  <p188:author id="{4C929E9C-F420-B6F3-90E2-7CDB7B1567CE}" name="Zelia Maria Cordeiro da Silva" initials="ZS" userId="S::zm.silva@fct.unl.pt::aebdcf6b-177f-45a0-a3f9-eeefaaf4426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4DEAEE-83E6-4709-99B9-6BA5F93F0AF0}" v="39" dt="2024-09-11T09:33:19.027"/>
    <p1510:client id="{BD059737-3CC4-A59B-F028-3A8D0D17B0BE}" v="6" dt="2024-09-11T15:31:18.167"/>
  </p1510:revLst>
</p1510:revInfo>
</file>

<file path=ppt/tableStyles.xml><?xml version="1.0" encoding="utf-8"?>
<a:tblStyleLst xmlns:a="http://schemas.openxmlformats.org/drawingml/2006/main" def="{26C38B20-5B04-4638-903F-0BECADDF9651}">
  <a:tblStyle styleId="{26C38B20-5B04-4638-903F-0BECADDF9651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61"/>
    <p:restoredTop sz="94718"/>
  </p:normalViewPr>
  <p:slideViewPr>
    <p:cSldViewPr snapToGrid="0">
      <p:cViewPr>
        <p:scale>
          <a:sx n="76" d="100"/>
          <a:sy n="76" d="100"/>
        </p:scale>
        <p:origin x="1484" y="-1584"/>
      </p:cViewPr>
      <p:guideLst>
        <p:guide orient="horz" pos="4056"/>
        <p:guide pos="1896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23" Type="http://customschemas.google.com/relationships/presentationmetadata" Target="metadata"/><Relationship Id="rId28" Type="http://schemas.microsoft.com/office/2016/11/relationships/changesInfo" Target="changesInfos/changesInfo1.xml"/><Relationship Id="rId4" Type="http://schemas.openxmlformats.org/officeDocument/2006/relationships/slide" Target="slides/slide3.xml"/><Relationship Id="rId27" Type="http://schemas.openxmlformats.org/officeDocument/2006/relationships/tableStyles" Target="tableStyles.xml"/><Relationship Id="rId30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elia Maria Cordeiro da Silva" userId="aebdcf6b-177f-45a0-a3f9-eeefaaf44269" providerId="ADAL" clId="{634DEAEE-83E6-4709-99B9-6BA5F93F0AF0}"/>
    <pc:docChg chg="undo custSel addSld modSld sldOrd">
      <pc:chgData name="Zelia Maria Cordeiro da Silva" userId="aebdcf6b-177f-45a0-a3f9-eeefaaf44269" providerId="ADAL" clId="{634DEAEE-83E6-4709-99B9-6BA5F93F0AF0}" dt="2024-09-11T10:09:20.214" v="45" actId="20577"/>
      <pc:docMkLst>
        <pc:docMk/>
      </pc:docMkLst>
      <pc:sldChg chg="modSp mod">
        <pc:chgData name="Zelia Maria Cordeiro da Silva" userId="aebdcf6b-177f-45a0-a3f9-eeefaaf44269" providerId="ADAL" clId="{634DEAEE-83E6-4709-99B9-6BA5F93F0AF0}" dt="2024-09-11T10:09:20.214" v="45" actId="20577"/>
        <pc:sldMkLst>
          <pc:docMk/>
          <pc:sldMk cId="0" sldId="260"/>
        </pc:sldMkLst>
        <pc:spChg chg="mod">
          <ac:chgData name="Zelia Maria Cordeiro da Silva" userId="aebdcf6b-177f-45a0-a3f9-eeefaaf44269" providerId="ADAL" clId="{634DEAEE-83E6-4709-99B9-6BA5F93F0AF0}" dt="2024-09-11T10:09:20.214" v="45" actId="20577"/>
          <ac:spMkLst>
            <pc:docMk/>
            <pc:sldMk cId="0" sldId="260"/>
            <ac:spMk id="259" creationId="{00000000-0000-0000-0000-000000000000}"/>
          </ac:spMkLst>
        </pc:spChg>
      </pc:sldChg>
      <pc:sldChg chg="addSp delSp modSp new mod ord">
        <pc:chgData name="Zelia Maria Cordeiro da Silva" userId="aebdcf6b-177f-45a0-a3f9-eeefaaf44269" providerId="ADAL" clId="{634DEAEE-83E6-4709-99B9-6BA5F93F0AF0}" dt="2024-09-11T10:09:03.285" v="43" actId="20577"/>
        <pc:sldMkLst>
          <pc:docMk/>
          <pc:sldMk cId="318029132" sldId="293"/>
        </pc:sldMkLst>
        <pc:spChg chg="del">
          <ac:chgData name="Zelia Maria Cordeiro da Silva" userId="aebdcf6b-177f-45a0-a3f9-eeefaaf44269" providerId="ADAL" clId="{634DEAEE-83E6-4709-99B9-6BA5F93F0AF0}" dt="2024-09-11T09:21:08.086" v="1" actId="478"/>
          <ac:spMkLst>
            <pc:docMk/>
            <pc:sldMk cId="318029132" sldId="293"/>
            <ac:spMk id="2" creationId="{E6D215CF-2D2E-C1AE-459E-671394354DA3}"/>
          </ac:spMkLst>
        </pc:spChg>
        <pc:spChg chg="del">
          <ac:chgData name="Zelia Maria Cordeiro da Silva" userId="aebdcf6b-177f-45a0-a3f9-eeefaaf44269" providerId="ADAL" clId="{634DEAEE-83E6-4709-99B9-6BA5F93F0AF0}" dt="2024-09-11T09:21:14.222" v="2" actId="478"/>
          <ac:spMkLst>
            <pc:docMk/>
            <pc:sldMk cId="318029132" sldId="293"/>
            <ac:spMk id="3" creationId="{B10DECFE-86AB-AE64-C10A-ECEC5704990D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0" creationId="{D125118E-4F94-DC86-05BD-2F8CA0127F62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1" creationId="{A451BAFD-E209-2289-D7F6-DA96E635489B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2" creationId="{7EEC21E9-551D-A48D-CF7D-57C5319524D6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3" creationId="{F9D6B467-E52D-6A14-2FC2-5558A70CA459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4" creationId="{869C06CD-F70C-28A2-550A-16B2A772CC3F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5" creationId="{C1F61DCD-BD89-EF45-08C1-6FE0A9639D26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6" creationId="{62610C92-576B-BBC6-373F-C9097C96CB23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7" creationId="{45B5DCCF-2786-E593-EB84-E59CDD8DD38F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8" creationId="{D2567901-BC7B-E6C8-E7C1-2EF33AAB8DA3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19" creationId="{831FE5A4-E7F1-930D-8EE2-0FB8534B2BBB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20" creationId="{C84AD6C8-AC50-66A3-11BC-208B6D01EC58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21" creationId="{7AA51319-1B3A-F790-165C-A11AB1C32F85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22" creationId="{9B8553F1-4E6B-8A01-1092-4EE580FDA066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23" creationId="{024DF129-A791-519C-3BCC-031D1F30B4A9}"/>
          </ac:spMkLst>
        </pc:spChg>
        <pc:spChg chg="mod topLvl">
          <ac:chgData name="Zelia Maria Cordeiro da Silva" userId="aebdcf6b-177f-45a0-a3f9-eeefaaf44269" providerId="ADAL" clId="{634DEAEE-83E6-4709-99B9-6BA5F93F0AF0}" dt="2024-09-11T09:30:24.862" v="30" actId="164"/>
          <ac:spMkLst>
            <pc:docMk/>
            <pc:sldMk cId="318029132" sldId="293"/>
            <ac:spMk id="24" creationId="{29572B18-3208-E950-8512-FD946E72217E}"/>
          </ac:spMkLst>
        </pc:spChg>
        <pc:spChg chg="add del mod">
          <ac:chgData name="Zelia Maria Cordeiro da Silva" userId="aebdcf6b-177f-45a0-a3f9-eeefaaf44269" providerId="ADAL" clId="{634DEAEE-83E6-4709-99B9-6BA5F93F0AF0}" dt="2024-09-11T09:31:57.818" v="33" actId="478"/>
          <ac:spMkLst>
            <pc:docMk/>
            <pc:sldMk cId="318029132" sldId="293"/>
            <ac:spMk id="28" creationId="{FBBE15D8-CA0F-788D-2D1A-E1328B2D3864}"/>
          </ac:spMkLst>
        </pc:spChg>
        <pc:spChg chg="add mod">
          <ac:chgData name="Zelia Maria Cordeiro da Silva" userId="aebdcf6b-177f-45a0-a3f9-eeefaaf44269" providerId="ADAL" clId="{634DEAEE-83E6-4709-99B9-6BA5F93F0AF0}" dt="2024-09-11T10:09:03.285" v="43" actId="20577"/>
          <ac:spMkLst>
            <pc:docMk/>
            <pc:sldMk cId="318029132" sldId="293"/>
            <ac:spMk id="29" creationId="{4DBF7585-A50F-57D6-A0C3-63EB043C5805}"/>
          </ac:spMkLst>
        </pc:spChg>
        <pc:grpChg chg="add del mod">
          <ac:chgData name="Zelia Maria Cordeiro da Silva" userId="aebdcf6b-177f-45a0-a3f9-eeefaaf44269" providerId="ADAL" clId="{634DEAEE-83E6-4709-99B9-6BA5F93F0AF0}" dt="2024-09-11T09:30:15.529" v="29" actId="165"/>
          <ac:grpSpMkLst>
            <pc:docMk/>
            <pc:sldMk cId="318029132" sldId="293"/>
            <ac:grpSpMk id="8" creationId="{E0664DF4-5224-5DD1-AB8B-ECA2CDB1B570}"/>
          </ac:grpSpMkLst>
        </pc:grpChg>
        <pc:grpChg chg="add mod">
          <ac:chgData name="Zelia Maria Cordeiro da Silva" userId="aebdcf6b-177f-45a0-a3f9-eeefaaf44269" providerId="ADAL" clId="{634DEAEE-83E6-4709-99B9-6BA5F93F0AF0}" dt="2024-09-11T09:30:30.259" v="31" actId="1076"/>
          <ac:grpSpMkLst>
            <pc:docMk/>
            <pc:sldMk cId="318029132" sldId="293"/>
            <ac:grpSpMk id="27" creationId="{6D6D1436-A30A-D7E1-EB9E-139390162C99}"/>
          </ac:grpSpMkLst>
        </pc:grpChg>
        <pc:picChg chg="add del mod">
          <ac:chgData name="Zelia Maria Cordeiro da Silva" userId="aebdcf6b-177f-45a0-a3f9-eeefaaf44269" providerId="ADAL" clId="{634DEAEE-83E6-4709-99B9-6BA5F93F0AF0}" dt="2024-09-11T09:23:11.053" v="5" actId="478"/>
          <ac:picMkLst>
            <pc:docMk/>
            <pc:sldMk cId="318029132" sldId="293"/>
            <ac:picMk id="4" creationId="{7EE445F4-3093-C0D3-6D5C-0ABD359C01E6}"/>
          </ac:picMkLst>
        </pc:picChg>
        <pc:picChg chg="add del mod">
          <ac:chgData name="Zelia Maria Cordeiro da Silva" userId="aebdcf6b-177f-45a0-a3f9-eeefaaf44269" providerId="ADAL" clId="{634DEAEE-83E6-4709-99B9-6BA5F93F0AF0}" dt="2024-09-11T09:25:26.073" v="13" actId="478"/>
          <ac:picMkLst>
            <pc:docMk/>
            <pc:sldMk cId="318029132" sldId="293"/>
            <ac:picMk id="5" creationId="{58811CEE-E7E6-4EB1-C4F4-2861C67AB6FA}"/>
          </ac:picMkLst>
        </pc:picChg>
        <pc:picChg chg="add del mod ord">
          <ac:chgData name="Zelia Maria Cordeiro da Silva" userId="aebdcf6b-177f-45a0-a3f9-eeefaaf44269" providerId="ADAL" clId="{634DEAEE-83E6-4709-99B9-6BA5F93F0AF0}" dt="2024-09-11T09:25:28.080" v="14" actId="478"/>
          <ac:picMkLst>
            <pc:docMk/>
            <pc:sldMk cId="318029132" sldId="293"/>
            <ac:picMk id="6" creationId="{77B95542-9458-65B8-9065-22007371E556}"/>
          </ac:picMkLst>
        </pc:picChg>
        <pc:picChg chg="add del mod">
          <ac:chgData name="Zelia Maria Cordeiro da Silva" userId="aebdcf6b-177f-45a0-a3f9-eeefaaf44269" providerId="ADAL" clId="{634DEAEE-83E6-4709-99B9-6BA5F93F0AF0}" dt="2024-09-11T09:25:23.989" v="12" actId="478"/>
          <ac:picMkLst>
            <pc:docMk/>
            <pc:sldMk cId="318029132" sldId="293"/>
            <ac:picMk id="7" creationId="{B340B9A5-7718-0522-70D7-FDAFCDBC7FF5}"/>
          </ac:picMkLst>
        </pc:picChg>
        <pc:picChg chg="mod topLvl">
          <ac:chgData name="Zelia Maria Cordeiro da Silva" userId="aebdcf6b-177f-45a0-a3f9-eeefaaf44269" providerId="ADAL" clId="{634DEAEE-83E6-4709-99B9-6BA5F93F0AF0}" dt="2024-09-11T09:30:24.862" v="30" actId="164"/>
          <ac:picMkLst>
            <pc:docMk/>
            <pc:sldMk cId="318029132" sldId="293"/>
            <ac:picMk id="9" creationId="{56429F7E-6A2B-D628-E465-2F19899659B6}"/>
          </ac:picMkLst>
        </pc:picChg>
        <pc:picChg chg="add del mod">
          <ac:chgData name="Zelia Maria Cordeiro da Silva" userId="aebdcf6b-177f-45a0-a3f9-eeefaaf44269" providerId="ADAL" clId="{634DEAEE-83E6-4709-99B9-6BA5F93F0AF0}" dt="2024-09-11T09:28:21.198" v="26" actId="478"/>
          <ac:picMkLst>
            <pc:docMk/>
            <pc:sldMk cId="318029132" sldId="293"/>
            <ac:picMk id="25" creationId="{8AB655F2-8EEB-4555-02EF-19DA3FBDF722}"/>
          </ac:picMkLst>
        </pc:picChg>
        <pc:picChg chg="add del mod">
          <ac:chgData name="Zelia Maria Cordeiro da Silva" userId="aebdcf6b-177f-45a0-a3f9-eeefaaf44269" providerId="ADAL" clId="{634DEAEE-83E6-4709-99B9-6BA5F93F0AF0}" dt="2024-09-11T09:27:35.231" v="22" actId="478"/>
          <ac:picMkLst>
            <pc:docMk/>
            <pc:sldMk cId="318029132" sldId="293"/>
            <ac:picMk id="26" creationId="{2AE6019F-F196-B2BA-34D9-1E8DE59953F6}"/>
          </ac:picMkLst>
        </pc:picChg>
      </pc:sldChg>
    </pc:docChg>
  </pc:docChgLst>
  <pc:docChgLst>
    <pc:chgData name="Zelia Maria Cordeiro da Silva" userId="S::zm.silva@fct.unl.pt::aebdcf6b-177f-45a0-a3f9-eeefaaf44269" providerId="AD" clId="Web-{BD059737-3CC4-A59B-F028-3A8D0D17B0BE}"/>
    <pc:docChg chg="addSld modSld">
      <pc:chgData name="Zelia Maria Cordeiro da Silva" userId="S::zm.silva@fct.unl.pt::aebdcf6b-177f-45a0-a3f9-eeefaaf44269" providerId="AD" clId="Web-{BD059737-3CC4-A59B-F028-3A8D0D17B0BE}" dt="2024-09-11T15:31:18.167" v="5"/>
      <pc:docMkLst>
        <pc:docMk/>
      </pc:docMkLst>
      <pc:sldChg chg="addSp delSp modSp new">
        <pc:chgData name="Zelia Maria Cordeiro da Silva" userId="S::zm.silva@fct.unl.pt::aebdcf6b-177f-45a0-a3f9-eeefaaf44269" providerId="AD" clId="Web-{BD059737-3CC4-A59B-F028-3A8D0D17B0BE}" dt="2024-09-11T15:31:18.167" v="5"/>
        <pc:sldMkLst>
          <pc:docMk/>
          <pc:sldMk cId="2450104216" sldId="294"/>
        </pc:sldMkLst>
        <pc:spChg chg="del">
          <ac:chgData name="Zelia Maria Cordeiro da Silva" userId="S::zm.silva@fct.unl.pt::aebdcf6b-177f-45a0-a3f9-eeefaaf44269" providerId="AD" clId="Web-{BD059737-3CC4-A59B-F028-3A8D0D17B0BE}" dt="2024-09-11T15:31:18.167" v="5"/>
          <ac:spMkLst>
            <pc:docMk/>
            <pc:sldMk cId="2450104216" sldId="294"/>
            <ac:spMk id="2" creationId="{B0144B3B-5849-AE6C-A28A-013ECE0155A9}"/>
          </ac:spMkLst>
        </pc:spChg>
        <pc:spChg chg="del">
          <ac:chgData name="Zelia Maria Cordeiro da Silva" userId="S::zm.silva@fct.unl.pt::aebdcf6b-177f-45a0-a3f9-eeefaaf44269" providerId="AD" clId="Web-{BD059737-3CC4-A59B-F028-3A8D0D17B0BE}" dt="2024-09-11T15:31:14.432" v="4"/>
          <ac:spMkLst>
            <pc:docMk/>
            <pc:sldMk cId="2450104216" sldId="294"/>
            <ac:spMk id="3" creationId="{154D5232-E131-546C-D45A-E2AD87D58A9B}"/>
          </ac:spMkLst>
        </pc:spChg>
        <pc:spChg chg="add del mod">
          <ac:chgData name="Zelia Maria Cordeiro da Silva" userId="S::zm.silva@fct.unl.pt::aebdcf6b-177f-45a0-a3f9-eeefaaf44269" providerId="AD" clId="Web-{BD059737-3CC4-A59B-F028-3A8D0D17B0BE}" dt="2024-09-11T15:31:05.182" v="3"/>
          <ac:spMkLst>
            <pc:docMk/>
            <pc:sldMk cId="2450104216" sldId="294"/>
            <ac:spMk id="4" creationId="{EE39BB31-0645-1B9D-9CBC-E13191B9770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pt-PT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  <p:extLst>
    <p:ext uri="{620B2872-D7B9-4A21-9093-7833F8D536E1}">
      <p15:sldGuideLst xmlns:p15="http://schemas.microsoft.com/office/powerpoint/2012/main">
        <p15:guide id="1" orient="horz" pos="2880">
          <p15:clr>
            <a:srgbClr val="F26B43"/>
          </p15:clr>
        </p15:guide>
        <p15:guide id="2" pos="2160">
          <p15:clr>
            <a:srgbClr val="F26B43"/>
          </p15:clr>
        </p15:guide>
      </p15:sldGuideLst>
    </p:ext>
  </p:extLst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57" name="Google Shape;257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m branc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3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39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4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3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3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e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40"/>
          <p:cNvSpPr txBox="1">
            <a:spLocks noGrp="1"/>
          </p:cNvSpPr>
          <p:nvPr>
            <p:ph type="title"/>
          </p:nvPr>
        </p:nvSpPr>
        <p:spPr>
          <a:xfrm rot="5400000">
            <a:off x="1449696" y="3985465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40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1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4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4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4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ó Título" type="titleOnly">
  <p:cSld name="TITLE_ONLY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3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3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3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o de Título" type="title">
  <p:cSld name="TITLE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31"/>
          <p:cNvSpPr txBox="1"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Arial"/>
              <a:buNone/>
              <a:defRPr sz="3375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31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350"/>
            </a:lvl1pPr>
            <a:lvl2pPr lvl="1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125"/>
            </a:lvl2pPr>
            <a:lvl3pPr lvl="2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013"/>
            </a:lvl3pPr>
            <a:lvl4pPr lvl="3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4pPr>
            <a:lvl5pPr lvl="4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5pPr>
            <a:lvl6pPr lvl="5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6pPr>
            <a:lvl7pPr lvl="6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7pPr>
            <a:lvl8pPr lvl="7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8pPr>
            <a:lvl9pPr lvl="8" algn="ctr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9pPr>
          </a:lstStyle>
          <a:p>
            <a:endParaRPr/>
          </a:p>
        </p:txBody>
      </p:sp>
      <p:sp>
        <p:nvSpPr>
          <p:cNvPr id="27" name="Google Shape;27;p3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3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3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Objeto" type="obj">
  <p:cSld name="OBJEC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3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3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3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3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3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beçalho da Secção" type="secHead">
  <p:cSld name="SECTION_HEADER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33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Arial"/>
              <a:buNone/>
              <a:defRPr sz="3375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33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28586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350">
                <a:solidFill>
                  <a:srgbClr val="888888"/>
                </a:solidFill>
              </a:defRPr>
            </a:lvl1pPr>
            <a:lvl2pPr marL="514344" lvl="1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125">
                <a:solidFill>
                  <a:srgbClr val="888888"/>
                </a:solidFill>
              </a:defRPr>
            </a:lvl2pPr>
            <a:lvl3pPr marL="771516" lvl="2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013">
                <a:solidFill>
                  <a:srgbClr val="888888"/>
                </a:solidFill>
              </a:defRPr>
            </a:lvl3pPr>
            <a:lvl4pPr marL="1028689" lvl="3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4pPr>
            <a:lvl5pPr marL="1285861" lvl="4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5pPr>
            <a:lvl6pPr marL="1543033" lvl="5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6pPr>
            <a:lvl7pPr marL="1800205" lvl="6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7pPr>
            <a:lvl8pPr marL="2057377" lvl="7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8pPr>
            <a:lvl9pPr marL="2314549" lvl="8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9" name="Google Shape;39;p3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3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3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údo Duplo" type="twoObj">
  <p:cSld name="TWO_OBJECTS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3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3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34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3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3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3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ção" type="twoTxTwoObj">
  <p:cSld name="TWO_OBJECTS_WITH_TEXT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35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35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57172" lvl="0" indent="-128586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350" b="1"/>
            </a:lvl1pPr>
            <a:lvl2pPr marL="514344" lvl="1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125" b="1"/>
            </a:lvl2pPr>
            <a:lvl3pPr marL="771516" lvl="2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013" b="1"/>
            </a:lvl3pPr>
            <a:lvl4pPr marL="1028689" lvl="3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4pPr>
            <a:lvl5pPr marL="1285861" lvl="4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5pPr>
            <a:lvl6pPr marL="1543033" lvl="5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6pPr>
            <a:lvl7pPr marL="1800205" lvl="6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7pPr>
            <a:lvl8pPr marL="2057377" lvl="7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8pPr>
            <a:lvl9pPr marL="2314549" lvl="8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9pPr>
          </a:lstStyle>
          <a:p>
            <a:endParaRPr/>
          </a:p>
        </p:txBody>
      </p:sp>
      <p:sp>
        <p:nvSpPr>
          <p:cNvPr id="52" name="Google Shape;52;p35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3" name="Google Shape;53;p35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57172" lvl="0" indent="-128586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350" b="1"/>
            </a:lvl1pPr>
            <a:lvl2pPr marL="514344" lvl="1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125" b="1"/>
            </a:lvl2pPr>
            <a:lvl3pPr marL="771516" lvl="2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013" b="1"/>
            </a:lvl3pPr>
            <a:lvl4pPr marL="1028689" lvl="3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4pPr>
            <a:lvl5pPr marL="1285861" lvl="4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5pPr>
            <a:lvl6pPr marL="1543033" lvl="5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6pPr>
            <a:lvl7pPr marL="1800205" lvl="6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7pPr>
            <a:lvl8pPr marL="2057377" lvl="7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8pPr>
            <a:lvl9pPr marL="2314549" lvl="8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 b="1"/>
            </a:lvl9pPr>
          </a:lstStyle>
          <a:p>
            <a:endParaRPr/>
          </a:p>
        </p:txBody>
      </p:sp>
      <p:sp>
        <p:nvSpPr>
          <p:cNvPr id="54" name="Google Shape;54;p35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92879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14344" lvl="1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771516" lvl="2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028689" lvl="3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285861" lvl="4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543033" lvl="5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800205" lvl="6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057377" lvl="7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314549" lvl="8" indent="-192879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5" name="Google Shape;55;p3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3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3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údo com Legenda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37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1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37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242885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1800"/>
            </a:lvl1pPr>
            <a:lvl2pPr marL="514344" lvl="1" indent="-228597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575"/>
            </a:lvl2pPr>
            <a:lvl3pPr marL="771516" lvl="2" indent="-214310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350"/>
            </a:lvl3pPr>
            <a:lvl4pPr marL="1028689" lvl="3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4pPr>
            <a:lvl5pPr marL="1285861" lvl="4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5pPr>
            <a:lvl6pPr marL="1543033" lvl="5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6pPr>
            <a:lvl7pPr marL="1800205" lvl="6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7pPr>
            <a:lvl8pPr marL="2057377" lvl="7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8pPr>
            <a:lvl9pPr marL="2314549" lvl="8" indent="-200023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125"/>
            </a:lvl9pPr>
          </a:lstStyle>
          <a:p>
            <a:endParaRPr/>
          </a:p>
        </p:txBody>
      </p:sp>
      <p:sp>
        <p:nvSpPr>
          <p:cNvPr id="61" name="Google Shape;61;p37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28586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1pPr>
            <a:lvl2pPr marL="514344" lvl="1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788"/>
            </a:lvl2pPr>
            <a:lvl3pPr marL="771516" lvl="2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675"/>
            </a:lvl3pPr>
            <a:lvl4pPr marL="1028689" lvl="3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4pPr>
            <a:lvl5pPr marL="1285861" lvl="4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5pPr>
            <a:lvl6pPr marL="1543033" lvl="5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6pPr>
            <a:lvl7pPr marL="1800205" lvl="6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7pPr>
            <a:lvl8pPr marL="2057377" lvl="7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8pPr>
            <a:lvl9pPr marL="2314549" lvl="8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9pPr>
          </a:lstStyle>
          <a:p>
            <a:endParaRPr/>
          </a:p>
        </p:txBody>
      </p:sp>
      <p:sp>
        <p:nvSpPr>
          <p:cNvPr id="62" name="Google Shape;62;p3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3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3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m com Legenda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38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1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38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38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57172" lvl="0" indent="-128586" algn="l">
              <a:lnSpc>
                <a:spcPct val="90000"/>
              </a:lnSpc>
              <a:spcBef>
                <a:spcPts val="563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00"/>
            </a:lvl1pPr>
            <a:lvl2pPr marL="514344" lvl="1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788"/>
            </a:lvl2pPr>
            <a:lvl3pPr marL="771516" lvl="2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675"/>
            </a:lvl3pPr>
            <a:lvl4pPr marL="1028689" lvl="3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4pPr>
            <a:lvl5pPr marL="1285861" lvl="4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5pPr>
            <a:lvl6pPr marL="1543033" lvl="5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6pPr>
            <a:lvl7pPr marL="1800205" lvl="6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7pPr>
            <a:lvl8pPr marL="2057377" lvl="7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8pPr>
            <a:lvl9pPr marL="2314549" lvl="8" indent="-128586" algn="l">
              <a:lnSpc>
                <a:spcPct val="90000"/>
              </a:lnSpc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563"/>
            </a:lvl9pPr>
          </a:lstStyle>
          <a:p>
            <a:endParaRPr/>
          </a:p>
        </p:txBody>
      </p:sp>
      <p:sp>
        <p:nvSpPr>
          <p:cNvPr id="69" name="Google Shape;69;p3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3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3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Arial"/>
              <a:buNone/>
              <a:defRPr sz="4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2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2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3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2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675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pt-PT" smtClean="0"/>
              <a:pPr/>
              <a:t>‹nº›</a:t>
            </a:fld>
            <a:endParaRPr lang="pt-PT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78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5.png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 descr="Uma imagem com texto, diagrama, captura de ecrã, design&#10;&#10;Descrição gerada automaticamente">
            <a:extLst>
              <a:ext uri="{FF2B5EF4-FFF2-40B4-BE49-F238E27FC236}">
                <a16:creationId xmlns:a16="http://schemas.microsoft.com/office/drawing/2014/main" id="{496B13EE-4100-26F1-BD84-8EF8F1FBAE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1448" y="2257161"/>
            <a:ext cx="2965301" cy="3258720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CC8BF41D-598A-92CE-0313-55FAA9032F24}"/>
              </a:ext>
            </a:extLst>
          </p:cNvPr>
          <p:cNvSpPr txBox="1"/>
          <p:nvPr/>
        </p:nvSpPr>
        <p:spPr>
          <a:xfrm>
            <a:off x="1449355" y="5445821"/>
            <a:ext cx="3810000" cy="397031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Figure S1- </a:t>
            </a:r>
            <a:r>
              <a:rPr lang="en-GB" sz="1200" dirty="0">
                <a:solidFill>
                  <a:srgbClr val="222222"/>
                </a:solidFill>
                <a:latin typeface="Times New Roman"/>
                <a:cs typeface="Times New Roman"/>
              </a:rPr>
              <a:t>PNA staining </a:t>
            </a:r>
            <a:r>
              <a:rPr lang="en-GB" sz="1200" dirty="0">
                <a:latin typeface="Times New Roman"/>
                <a:cs typeface="Times New Roman"/>
              </a:rPr>
              <a:t>levels were assessed by flow cytometry after </a:t>
            </a:r>
            <a:r>
              <a:rPr lang="en-GB" sz="1200" dirty="0" err="1">
                <a:latin typeface="Times New Roman"/>
                <a:cs typeface="Times New Roman"/>
              </a:rPr>
              <a:t>MoDCs</a:t>
            </a:r>
            <a:r>
              <a:rPr lang="en-GB" sz="1200" dirty="0">
                <a:latin typeface="Times New Roman"/>
                <a:cs typeface="Times New Roman"/>
              </a:rPr>
              <a:t> were treated with different sialidases. Enzymatic removal of sialic acid from the cell surface was performed using sialidases from different origins.. Cells (5 × 10</a:t>
            </a:r>
            <a:r>
              <a:rPr lang="en-GB" sz="800" baseline="30000" dirty="0">
                <a:latin typeface="Times New Roman"/>
                <a:cs typeface="Times New Roman"/>
              </a:rPr>
              <a:t>6</a:t>
            </a:r>
            <a:r>
              <a:rPr lang="en-GB" sz="1200" dirty="0">
                <a:latin typeface="Times New Roman"/>
                <a:cs typeface="Times New Roman"/>
              </a:rPr>
              <a:t> / mL) were resuspended in RPMI medium containing 100 </a:t>
            </a:r>
            <a:r>
              <a:rPr lang="en-GB" sz="1200" dirty="0" err="1">
                <a:latin typeface="Times New Roman"/>
                <a:cs typeface="Times New Roman"/>
              </a:rPr>
              <a:t>mU</a:t>
            </a:r>
            <a:r>
              <a:rPr lang="en-GB" sz="1200" dirty="0">
                <a:latin typeface="Times New Roman"/>
                <a:cs typeface="Times New Roman"/>
              </a:rPr>
              <a:t> of sialidase for each 10</a:t>
            </a:r>
            <a:r>
              <a:rPr lang="en-GB" sz="800" baseline="30000" dirty="0">
                <a:latin typeface="Times New Roman"/>
                <a:cs typeface="Times New Roman"/>
              </a:rPr>
              <a:t>6</a:t>
            </a:r>
            <a:r>
              <a:rPr lang="en-GB" sz="1200" dirty="0">
                <a:latin typeface="Times New Roman"/>
                <a:cs typeface="Times New Roman"/>
              </a:rPr>
              <a:t> cells and incubated for 1h at 37ºC. After incubation, 1 mL of RPMI medium containing 10% FBS was added to stop the enzymatic reaction, and the cells were centrifuged, discarding the supernatant. Cells were stained with the FITC-conjugated PNA for 30 min at 4 ºC in the dark. After staining, cells were washed and then fixed within 2 % paraformaldehyde. The data was acquired in Attune flow cytometer (</a:t>
            </a:r>
            <a:r>
              <a:rPr lang="en-GB" sz="1200" dirty="0" err="1">
                <a:latin typeface="Times New Roman"/>
                <a:cs typeface="Times New Roman"/>
              </a:rPr>
              <a:t>ThermoFisher</a:t>
            </a:r>
            <a:r>
              <a:rPr lang="en-GB" sz="1200" dirty="0">
                <a:latin typeface="Times New Roman"/>
                <a:cs typeface="Times New Roman"/>
              </a:rPr>
              <a:t> Scientific, USA) followed by analysis using </a:t>
            </a:r>
            <a:r>
              <a:rPr lang="en-GB" sz="1200" dirty="0" err="1">
                <a:latin typeface="Times New Roman"/>
                <a:cs typeface="Times New Roman"/>
              </a:rPr>
              <a:t>FlowJo</a:t>
            </a:r>
            <a:r>
              <a:rPr lang="en-GB" sz="800" baseline="30000" dirty="0" err="1">
                <a:latin typeface="Times New Roman"/>
                <a:cs typeface="Times New Roman"/>
              </a:rPr>
              <a:t>TM</a:t>
            </a:r>
            <a:r>
              <a:rPr lang="en-GB" sz="1200" dirty="0">
                <a:latin typeface="Times New Roman"/>
                <a:cs typeface="Times New Roman"/>
              </a:rPr>
              <a:t> V10.8 software (BD Life Sciences). Bars represent MFI ratios (</a:t>
            </a:r>
            <a:r>
              <a:rPr lang="en-GB" sz="1200" dirty="0" err="1">
                <a:latin typeface="Times New Roman"/>
                <a:cs typeface="Times New Roman"/>
              </a:rPr>
              <a:t>mean±SEM</a:t>
            </a:r>
            <a:r>
              <a:rPr lang="en-GB" sz="1200" dirty="0">
                <a:latin typeface="Times New Roman"/>
                <a:cs typeface="Times New Roman"/>
              </a:rPr>
              <a:t>). , MFI of sialidase-treated cells divided by   MFI of untreated cells.  from at least three different donors. </a:t>
            </a:r>
            <a:r>
              <a:rPr lang="en-GB" sz="1200" dirty="0">
                <a:solidFill>
                  <a:srgbClr val="222222"/>
                </a:solidFill>
                <a:latin typeface="Times New Roman"/>
                <a:cs typeface="Times New Roman"/>
              </a:rPr>
              <a:t> Statistically significant differences are indicated by asterisks (* </a:t>
            </a:r>
            <a:r>
              <a:rPr lang="en-GB" sz="1200" i="1" dirty="0">
                <a:solidFill>
                  <a:srgbClr val="222222"/>
                </a:solidFill>
                <a:latin typeface="Times New Roman"/>
                <a:cs typeface="Times New Roman"/>
              </a:rPr>
              <a:t>p</a:t>
            </a:r>
            <a:r>
              <a:rPr lang="en-GB" sz="1200" dirty="0">
                <a:solidFill>
                  <a:srgbClr val="222222"/>
                </a:solidFill>
                <a:latin typeface="Times New Roman"/>
                <a:cs typeface="Times New Roman"/>
              </a:rPr>
              <a:t> &lt; 0.05).</a:t>
            </a:r>
            <a:r>
              <a:rPr lang="en-GB" sz="1200" dirty="0">
                <a:latin typeface="Times New Roman"/>
                <a:cs typeface="Times New Roman"/>
              </a:rPr>
              <a:t> </a:t>
            </a:r>
            <a:endParaRPr lang="en-GB" sz="1200" dirty="0">
              <a:solidFill>
                <a:srgbClr val="222222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480799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229;p2">
            <a:extLst>
              <a:ext uri="{FF2B5EF4-FFF2-40B4-BE49-F238E27FC236}">
                <a16:creationId xmlns:a16="http://schemas.microsoft.com/office/drawing/2014/main" id="{11A41210-C6D2-1F7E-6568-DBF5BBF3095D}"/>
              </a:ext>
            </a:extLst>
          </p:cNvPr>
          <p:cNvSpPr txBox="1"/>
          <p:nvPr/>
        </p:nvSpPr>
        <p:spPr>
          <a:xfrm>
            <a:off x="2549819" y="2864316"/>
            <a:ext cx="528740" cy="2058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1427" tIns="25706" rIns="51427" bIns="25706" anchor="t" anchorCtr="0">
            <a:spAutoFit/>
          </a:bodyPr>
          <a:lstStyle/>
          <a:p>
            <a:pPr algn="ctr">
              <a:buSzPts val="1200"/>
            </a:pPr>
            <a:r>
              <a:rPr lang="pt-PT" sz="1000" b="1"/>
              <a:t>MHC-I</a:t>
            </a:r>
            <a:endParaRPr sz="100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047B5A4-CBA6-C8D7-C068-8F3E649BFCCD}"/>
              </a:ext>
            </a:extLst>
          </p:cNvPr>
          <p:cNvGrpSpPr/>
          <p:nvPr/>
        </p:nvGrpSpPr>
        <p:grpSpPr>
          <a:xfrm>
            <a:off x="1784989" y="5193512"/>
            <a:ext cx="2063819" cy="155790"/>
            <a:chOff x="1784989" y="5193512"/>
            <a:chExt cx="2063819" cy="155790"/>
          </a:xfrm>
        </p:grpSpPr>
        <p:grpSp>
          <p:nvGrpSpPr>
            <p:cNvPr id="4" name="Agrupar 17">
              <a:extLst>
                <a:ext uri="{FF2B5EF4-FFF2-40B4-BE49-F238E27FC236}">
                  <a16:creationId xmlns:a16="http://schemas.microsoft.com/office/drawing/2014/main" id="{477A798C-A0A9-1A93-2089-3CE391D37357}"/>
                </a:ext>
              </a:extLst>
            </p:cNvPr>
            <p:cNvGrpSpPr/>
            <p:nvPr/>
          </p:nvGrpSpPr>
          <p:grpSpPr>
            <a:xfrm>
              <a:off x="1784989" y="5193512"/>
              <a:ext cx="2063819" cy="155790"/>
              <a:chOff x="360757" y="4155515"/>
              <a:chExt cx="2063819" cy="155790"/>
            </a:xfrm>
          </p:grpSpPr>
          <p:grpSp>
            <p:nvGrpSpPr>
              <p:cNvPr id="5" name="Google Shape;220;p2">
                <a:extLst>
                  <a:ext uri="{FF2B5EF4-FFF2-40B4-BE49-F238E27FC236}">
                    <a16:creationId xmlns:a16="http://schemas.microsoft.com/office/drawing/2014/main" id="{F26A6DB9-0417-E664-9A7A-0C0A04EA5A3E}"/>
                  </a:ext>
                </a:extLst>
              </p:cNvPr>
              <p:cNvGrpSpPr/>
              <p:nvPr/>
            </p:nvGrpSpPr>
            <p:grpSpPr>
              <a:xfrm>
                <a:off x="360757" y="4155515"/>
                <a:ext cx="528925" cy="155789"/>
                <a:chOff x="16910730" y="-218603"/>
                <a:chExt cx="1021781" cy="324275"/>
              </a:xfrm>
            </p:grpSpPr>
            <p:sp>
              <p:nvSpPr>
                <p:cNvPr id="12" name="Google Shape;221;p2">
                  <a:extLst>
                    <a:ext uri="{FF2B5EF4-FFF2-40B4-BE49-F238E27FC236}">
                      <a16:creationId xmlns:a16="http://schemas.microsoft.com/office/drawing/2014/main" id="{3FFDFD48-C322-60BA-BF97-E867AF40F9D1}"/>
                    </a:ext>
                  </a:extLst>
                </p:cNvPr>
                <p:cNvSpPr/>
                <p:nvPr/>
              </p:nvSpPr>
              <p:spPr>
                <a:xfrm>
                  <a:off x="16910730" y="-159382"/>
                  <a:ext cx="209099" cy="22480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txBody>
                <a:bodyPr spcFirstLastPara="1" wrap="square" lIns="51427" tIns="25706" rIns="51427" bIns="25706" anchor="ctr" anchorCtr="0">
                  <a:noAutofit/>
                </a:bodyPr>
                <a:lstStyle/>
                <a:p>
                  <a:pPr algn="ctr">
                    <a:buSzPts val="1400"/>
                  </a:pPr>
                  <a:endParaRPr sz="788">
                    <a:solidFill>
                      <a:schemeClr val="lt1"/>
                    </a:solidFill>
                  </a:endParaRPr>
                </a:p>
              </p:txBody>
            </p:sp>
            <p:sp>
              <p:nvSpPr>
                <p:cNvPr id="13" name="Google Shape;222;p2">
                  <a:extLst>
                    <a:ext uri="{FF2B5EF4-FFF2-40B4-BE49-F238E27FC236}">
                      <a16:creationId xmlns:a16="http://schemas.microsoft.com/office/drawing/2014/main" id="{C0A7B855-E879-10B7-1B38-68C9236E8C2C}"/>
                    </a:ext>
                  </a:extLst>
                </p:cNvPr>
                <p:cNvSpPr txBox="1"/>
                <p:nvPr/>
              </p:nvSpPr>
              <p:spPr>
                <a:xfrm>
                  <a:off x="17164092" y="-218603"/>
                  <a:ext cx="768419" cy="32427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51427" tIns="25706" rIns="51427" bIns="25706" anchor="t" anchorCtr="0">
                  <a:spAutoFit/>
                </a:bodyPr>
                <a:lstStyle/>
                <a:p>
                  <a:pPr>
                    <a:buSzPts val="1200"/>
                  </a:pPr>
                  <a:r>
                    <a:rPr lang="pt-PT" sz="675" err="1"/>
                    <a:t>Isotype</a:t>
                  </a:r>
                  <a:r>
                    <a:rPr lang="pt-PT" sz="675"/>
                    <a:t> </a:t>
                  </a:r>
                  <a:endParaRPr sz="675"/>
                </a:p>
              </p:txBody>
            </p:sp>
          </p:grpSp>
          <p:grpSp>
            <p:nvGrpSpPr>
              <p:cNvPr id="6" name="Google Shape;223;p2">
                <a:extLst>
                  <a:ext uri="{FF2B5EF4-FFF2-40B4-BE49-F238E27FC236}">
                    <a16:creationId xmlns:a16="http://schemas.microsoft.com/office/drawing/2014/main" id="{B9D06180-E55A-A186-D468-7633D8FC0930}"/>
                  </a:ext>
                </a:extLst>
              </p:cNvPr>
              <p:cNvGrpSpPr/>
              <p:nvPr/>
            </p:nvGrpSpPr>
            <p:grpSpPr>
              <a:xfrm>
                <a:off x="889308" y="4155516"/>
                <a:ext cx="528685" cy="155789"/>
                <a:chOff x="4631212" y="841621"/>
                <a:chExt cx="889440" cy="266831"/>
              </a:xfrm>
            </p:grpSpPr>
            <p:sp>
              <p:nvSpPr>
                <p:cNvPr id="10" name="Google Shape;224;p2">
                  <a:extLst>
                    <a:ext uri="{FF2B5EF4-FFF2-40B4-BE49-F238E27FC236}">
                      <a16:creationId xmlns:a16="http://schemas.microsoft.com/office/drawing/2014/main" id="{195AF850-80A6-805D-1D1A-FAB4850DB5ED}"/>
                    </a:ext>
                  </a:extLst>
                </p:cNvPr>
                <p:cNvSpPr/>
                <p:nvPr/>
              </p:nvSpPr>
              <p:spPr>
                <a:xfrm>
                  <a:off x="4631212" y="885837"/>
                  <a:ext cx="181695" cy="185195"/>
                </a:xfrm>
                <a:prstGeom prst="rect">
                  <a:avLst/>
                </a:prstGeom>
                <a:solidFill>
                  <a:srgbClr val="BFBFBF"/>
                </a:solidFill>
                <a:ln>
                  <a:solidFill>
                    <a:srgbClr val="BFBFBF"/>
                  </a:solidFill>
                </a:ln>
              </p:spPr>
              <p:txBody>
                <a:bodyPr spcFirstLastPara="1" wrap="square" lIns="51427" tIns="25706" rIns="51427" bIns="25706" anchor="ctr" anchorCtr="0">
                  <a:noAutofit/>
                </a:bodyPr>
                <a:lstStyle/>
                <a:p>
                  <a:pPr algn="ctr">
                    <a:buSzPts val="1400"/>
                  </a:pPr>
                  <a:endParaRPr sz="788">
                    <a:solidFill>
                      <a:schemeClr val="lt1"/>
                    </a:solidFill>
                  </a:endParaRPr>
                </a:p>
              </p:txBody>
            </p:sp>
            <p:sp>
              <p:nvSpPr>
                <p:cNvPr id="11" name="Google Shape;225;p2">
                  <a:extLst>
                    <a:ext uri="{FF2B5EF4-FFF2-40B4-BE49-F238E27FC236}">
                      <a16:creationId xmlns:a16="http://schemas.microsoft.com/office/drawing/2014/main" id="{F544E881-7B0D-F04B-4A14-152CE755922A}"/>
                    </a:ext>
                  </a:extLst>
                </p:cNvPr>
                <p:cNvSpPr txBox="1"/>
                <p:nvPr/>
              </p:nvSpPr>
              <p:spPr>
                <a:xfrm>
                  <a:off x="4851455" y="841621"/>
                  <a:ext cx="669197" cy="26683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51427" tIns="25706" rIns="51427" bIns="25706" anchor="t" anchorCtr="0">
                  <a:spAutoFit/>
                </a:bodyPr>
                <a:lstStyle/>
                <a:p>
                  <a:pPr>
                    <a:buSzPts val="1400"/>
                  </a:pPr>
                  <a:r>
                    <a:rPr lang="pt-PT" sz="675"/>
                    <a:t>Control</a:t>
                  </a:r>
                  <a:endParaRPr sz="675"/>
                </a:p>
              </p:txBody>
            </p:sp>
          </p:grpSp>
          <p:sp>
            <p:nvSpPr>
              <p:cNvPr id="8" name="Google Shape;246;p2">
                <a:extLst>
                  <a:ext uri="{FF2B5EF4-FFF2-40B4-BE49-F238E27FC236}">
                    <a16:creationId xmlns:a16="http://schemas.microsoft.com/office/drawing/2014/main" id="{C987CFC1-0211-C5FD-FF94-93FAD74D8C61}"/>
                  </a:ext>
                </a:extLst>
              </p:cNvPr>
              <p:cNvSpPr txBox="1"/>
              <p:nvPr/>
            </p:nvSpPr>
            <p:spPr>
              <a:xfrm>
                <a:off x="1584959" y="4155515"/>
                <a:ext cx="839617" cy="15578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51427" tIns="25706" rIns="51427" bIns="25706" anchor="t" anchorCtr="0">
                <a:spAutoFit/>
              </a:bodyPr>
              <a:lstStyle/>
              <a:p>
                <a:pPr>
                  <a:buSzPts val="1400"/>
                </a:pPr>
                <a:r>
                  <a:rPr lang="pt-PT" sz="675" err="1"/>
                  <a:t>Sialidase</a:t>
                </a:r>
                <a:r>
                  <a:rPr lang="pt-PT" sz="675"/>
                  <a:t> </a:t>
                </a:r>
                <a:r>
                  <a:rPr lang="pt-PT" sz="675" err="1"/>
                  <a:t>treatment</a:t>
                </a:r>
                <a:endParaRPr sz="675"/>
              </a:p>
            </p:txBody>
          </p:sp>
        </p:grpSp>
        <p:sp>
          <p:nvSpPr>
            <p:cNvPr id="15" name="Google Shape;221;p2">
              <a:extLst>
                <a:ext uri="{FF2B5EF4-FFF2-40B4-BE49-F238E27FC236}">
                  <a16:creationId xmlns:a16="http://schemas.microsoft.com/office/drawing/2014/main" id="{FD929C4F-F6B0-D160-1971-1E92FD0E75F9}"/>
                </a:ext>
              </a:extLst>
            </p:cNvPr>
            <p:cNvSpPr/>
            <p:nvPr/>
          </p:nvSpPr>
          <p:spPr>
            <a:xfrm>
              <a:off x="2877394" y="5218279"/>
              <a:ext cx="108240" cy="108000"/>
            </a:xfrm>
            <a:prstGeom prst="rect">
              <a:avLst/>
            </a:prstGeom>
            <a:noFill/>
            <a:ln>
              <a:solidFill>
                <a:srgbClr val="3D3D3D"/>
              </a:solidFill>
              <a:prstDash val="sysDot"/>
            </a:ln>
          </p:spPr>
          <p:txBody>
            <a:bodyPr spcFirstLastPara="1" wrap="square" lIns="51427" tIns="25706" rIns="51427" bIns="25706" anchor="ctr" anchorCtr="0">
              <a:noAutofit/>
            </a:bodyPr>
            <a:lstStyle/>
            <a:p>
              <a:pPr algn="ctr">
                <a:buSzPts val="1400"/>
              </a:pPr>
              <a:endParaRPr sz="788">
                <a:solidFill>
                  <a:schemeClr val="lt1"/>
                </a:solidFill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1C39B62C-9EF0-FBD0-BE21-4FD6BDACA206}"/>
              </a:ext>
            </a:extLst>
          </p:cNvPr>
          <p:cNvSpPr txBox="1"/>
          <p:nvPr/>
        </p:nvSpPr>
        <p:spPr>
          <a:xfrm>
            <a:off x="1006596" y="5375117"/>
            <a:ext cx="3615186" cy="378565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Fig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lang="pt-PT" sz="1200" b="1" dirty="0">
                <a:latin typeface="Times New Roman"/>
                <a:cs typeface="Times New Roman"/>
              </a:rPr>
              <a:t>S2-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Sialidase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reatment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increases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he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cell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surface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expression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of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MHC-I in THP-1 </a:t>
            </a:r>
            <a:r>
              <a:rPr kumimoji="0" lang="pt-PT" sz="12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monocytes</a:t>
            </a:r>
            <a:r>
              <a:rPr kumimoji="0" lang="pt-PT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.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Representative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histograma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from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he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staining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of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THP-1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monocytes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with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antibodies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against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he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MHC-I,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after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sialidase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</a:t>
            </a:r>
            <a:r>
              <a:rPr kumimoji="0" lang="pt-PT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reatment</a:t>
            </a:r>
            <a:r>
              <a:rPr kumimoji="0" lang="pt-PT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.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Enzymatic removal of sialic acid from the cell surface was performed using sialidase from </a:t>
            </a:r>
            <a:r>
              <a:rPr kumimoji="0" lang="en-GB" sz="120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Clostridium perfringens 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(Roche Diagnostics, Basel, Switzerland). Cells (5 × 10</a:t>
            </a:r>
            <a:r>
              <a:rPr kumimoji="0" lang="en-GB" sz="1200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6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/ mL) were resuspended in RPMI medium containing 100 </a:t>
            </a:r>
            <a:r>
              <a:rPr kumimoji="0" lang="en-GB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mU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of sialidase for each 10</a:t>
            </a:r>
            <a:r>
              <a:rPr kumimoji="0" lang="en-GB" sz="1200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6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cells and incubated for 1h at 37ºC. After incubation, 1 mL of RPMI medium containing 10% FBS was added to stop the enzymatic reaction, and the cells were centrifuged, discarding the supernatant. Cells were stained with the FITC-conjugated anti-MHC-I (W6/32) for 30 min at 4 ºC in the dark. After staining, cells were fixed within 2 % paraformaldehyde. The data was acquired in Attune flow cytometer (</a:t>
            </a:r>
            <a:r>
              <a:rPr kumimoji="0" lang="en-GB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hermoFisher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Scientific, USA) followed by analysis using </a:t>
            </a:r>
            <a:r>
              <a:rPr kumimoji="0" lang="en-GB" sz="120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FlowJo</a:t>
            </a:r>
            <a:r>
              <a:rPr kumimoji="0" lang="en-GB" sz="1200" i="0" u="none" strike="noStrike" kern="0" cap="none" spc="0" normalizeH="0" baseline="3000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TM</a:t>
            </a:r>
            <a:r>
              <a:rPr kumimoji="0" lang="en-GB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cs typeface="Times New Roman"/>
                <a:sym typeface="Arial"/>
              </a:rPr>
              <a:t> V10.8 software (BD Life Sciences).</a:t>
            </a:r>
            <a:endParaRPr lang="en-GB" sz="1200" dirty="0">
              <a:latin typeface="Times New Roman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8E0D96D-56F2-5A7A-6AC8-BCDA5A8049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4189" y="3068590"/>
            <a:ext cx="216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744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Agrupar 26">
            <a:extLst>
              <a:ext uri="{FF2B5EF4-FFF2-40B4-BE49-F238E27FC236}">
                <a16:creationId xmlns:a16="http://schemas.microsoft.com/office/drawing/2014/main" id="{6D6D1436-A30A-D7E1-EB9E-139390162C99}"/>
              </a:ext>
            </a:extLst>
          </p:cNvPr>
          <p:cNvGrpSpPr/>
          <p:nvPr/>
        </p:nvGrpSpPr>
        <p:grpSpPr>
          <a:xfrm>
            <a:off x="453008" y="880301"/>
            <a:ext cx="5396354" cy="4730453"/>
            <a:chOff x="453008" y="5012034"/>
            <a:chExt cx="5396354" cy="4730453"/>
          </a:xfrm>
        </p:grpSpPr>
        <p:pic>
          <p:nvPicPr>
            <p:cNvPr id="9" name="Imagem 8">
              <a:extLst>
                <a:ext uri="{FF2B5EF4-FFF2-40B4-BE49-F238E27FC236}">
                  <a16:creationId xmlns:a16="http://schemas.microsoft.com/office/drawing/2014/main" id="{56429F7E-6A2B-D628-E465-2F1989965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5321"/>
            <a:stretch/>
          </p:blipFill>
          <p:spPr>
            <a:xfrm>
              <a:off x="453008" y="5012034"/>
              <a:ext cx="5396354" cy="4730453"/>
            </a:xfrm>
            <a:prstGeom prst="rect">
              <a:avLst/>
            </a:prstGeom>
          </p:spPr>
        </p:pic>
        <p:sp>
          <p:nvSpPr>
            <p:cNvPr id="10" name="CaixaDeTexto 9">
              <a:extLst>
                <a:ext uri="{FF2B5EF4-FFF2-40B4-BE49-F238E27FC236}">
                  <a16:creationId xmlns:a16="http://schemas.microsoft.com/office/drawing/2014/main" id="{D125118E-4F94-DC86-05BD-2F8CA0127F62}"/>
                </a:ext>
              </a:extLst>
            </p:cNvPr>
            <p:cNvSpPr txBox="1"/>
            <p:nvPr/>
          </p:nvSpPr>
          <p:spPr>
            <a:xfrm>
              <a:off x="1703199" y="6383525"/>
              <a:ext cx="949285" cy="376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dirty="0" err="1"/>
                <a:t>PBMCs</a:t>
              </a:r>
              <a:endParaRPr lang="pt-PT" dirty="0"/>
            </a:p>
          </p:txBody>
        </p:sp>
        <p:sp>
          <p:nvSpPr>
            <p:cNvPr id="11" name="CaixaDeTexto 10">
              <a:extLst>
                <a:ext uri="{FF2B5EF4-FFF2-40B4-BE49-F238E27FC236}">
                  <a16:creationId xmlns:a16="http://schemas.microsoft.com/office/drawing/2014/main" id="{A451BAFD-E209-2289-D7F6-DA96E635489B}"/>
                </a:ext>
              </a:extLst>
            </p:cNvPr>
            <p:cNvSpPr txBox="1"/>
            <p:nvPr/>
          </p:nvSpPr>
          <p:spPr>
            <a:xfrm>
              <a:off x="1703199" y="7029979"/>
              <a:ext cx="949285" cy="376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dirty="0" err="1"/>
                <a:t>PBMCs</a:t>
              </a:r>
              <a:endParaRPr lang="pt-PT" sz="1600" dirty="0"/>
            </a:p>
          </p:txBody>
        </p:sp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7EEC21E9-551D-A48D-CF7D-57C5319524D6}"/>
                </a:ext>
              </a:extLst>
            </p:cNvPr>
            <p:cNvSpPr txBox="1"/>
            <p:nvPr/>
          </p:nvSpPr>
          <p:spPr>
            <a:xfrm>
              <a:off x="1685481" y="7577182"/>
              <a:ext cx="1973310" cy="376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baseline="30000" dirty="0"/>
                <a:t> </a:t>
              </a:r>
              <a:r>
                <a:rPr lang="pt-PT" sz="1600" dirty="0" err="1"/>
                <a:t>PBMCs</a:t>
              </a:r>
              <a:r>
                <a:rPr lang="pt-PT" sz="1600" dirty="0"/>
                <a:t> + </a:t>
              </a:r>
              <a:r>
                <a:rPr lang="pt-PT" sz="1600" dirty="0" err="1"/>
                <a:t>PMA+Io</a:t>
              </a:r>
              <a:endParaRPr lang="pt-PT" sz="1600" dirty="0"/>
            </a:p>
          </p:txBody>
        </p:sp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F9D6B467-E52D-6A14-2FC2-5558A70CA459}"/>
                </a:ext>
              </a:extLst>
            </p:cNvPr>
            <p:cNvSpPr txBox="1"/>
            <p:nvPr/>
          </p:nvSpPr>
          <p:spPr>
            <a:xfrm>
              <a:off x="1703199" y="8146314"/>
              <a:ext cx="1654561" cy="376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dirty="0"/>
                <a:t> </a:t>
              </a:r>
              <a:r>
                <a:rPr lang="pt-PT" sz="1600" dirty="0" err="1"/>
                <a:t>PBMCs</a:t>
              </a:r>
              <a:r>
                <a:rPr lang="pt-PT" sz="1600" dirty="0"/>
                <a:t> + </a:t>
              </a:r>
              <a:r>
                <a:rPr lang="pt-PT" sz="1600" dirty="0" err="1"/>
                <a:t>DCs</a:t>
              </a:r>
              <a:endParaRPr lang="pt-PT" sz="1600" dirty="0"/>
            </a:p>
          </p:txBody>
        </p:sp>
        <p:sp>
          <p:nvSpPr>
            <p:cNvPr id="14" name="CaixaDeTexto 13">
              <a:extLst>
                <a:ext uri="{FF2B5EF4-FFF2-40B4-BE49-F238E27FC236}">
                  <a16:creationId xmlns:a16="http://schemas.microsoft.com/office/drawing/2014/main" id="{869C06CD-F70C-28A2-550A-16B2A772CC3F}"/>
                </a:ext>
              </a:extLst>
            </p:cNvPr>
            <p:cNvSpPr txBox="1"/>
            <p:nvPr/>
          </p:nvSpPr>
          <p:spPr>
            <a:xfrm>
              <a:off x="1686313" y="8715447"/>
              <a:ext cx="2205961" cy="376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dirty="0" err="1"/>
                <a:t>PBMCs</a:t>
              </a:r>
              <a:r>
                <a:rPr lang="pt-PT" sz="1600" dirty="0"/>
                <a:t> +</a:t>
              </a:r>
              <a:r>
                <a:rPr lang="pt-PT" sz="1600" dirty="0" err="1"/>
                <a:t>DCs</a:t>
              </a:r>
              <a:r>
                <a:rPr lang="pt-PT" sz="1600" dirty="0"/>
                <a:t> </a:t>
              </a:r>
              <a:r>
                <a:rPr lang="pt-PT" sz="1600" baseline="30000" dirty="0" err="1"/>
                <a:t>sialidase</a:t>
              </a:r>
              <a:endParaRPr lang="pt-PT" sz="1600" baseline="30000" dirty="0"/>
            </a:p>
          </p:txBody>
        </p:sp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C1F61DCD-BD89-EF45-08C1-6FE0A9639D26}"/>
                </a:ext>
              </a:extLst>
            </p:cNvPr>
            <p:cNvSpPr txBox="1"/>
            <p:nvPr/>
          </p:nvSpPr>
          <p:spPr>
            <a:xfrm>
              <a:off x="4911296" y="6993120"/>
              <a:ext cx="711139" cy="442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dirty="0"/>
                <a:t>19%</a:t>
              </a:r>
            </a:p>
          </p:txBody>
        </p:sp>
        <p:sp>
          <p:nvSpPr>
            <p:cNvPr id="16" name="CaixaDeTexto 15">
              <a:extLst>
                <a:ext uri="{FF2B5EF4-FFF2-40B4-BE49-F238E27FC236}">
                  <a16:creationId xmlns:a16="http://schemas.microsoft.com/office/drawing/2014/main" id="{62610C92-576B-BBC6-373F-C9097C96CB23}"/>
                </a:ext>
              </a:extLst>
            </p:cNvPr>
            <p:cNvSpPr txBox="1"/>
            <p:nvPr/>
          </p:nvSpPr>
          <p:spPr>
            <a:xfrm>
              <a:off x="4911296" y="7575440"/>
              <a:ext cx="711139" cy="442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dirty="0"/>
                <a:t>52%</a:t>
              </a:r>
            </a:p>
          </p:txBody>
        </p:sp>
        <p:sp>
          <p:nvSpPr>
            <p:cNvPr id="17" name="CaixaDeTexto 16">
              <a:extLst>
                <a:ext uri="{FF2B5EF4-FFF2-40B4-BE49-F238E27FC236}">
                  <a16:creationId xmlns:a16="http://schemas.microsoft.com/office/drawing/2014/main" id="{45B5DCCF-2786-E593-EB84-E59CDD8DD38F}"/>
                </a:ext>
              </a:extLst>
            </p:cNvPr>
            <p:cNvSpPr txBox="1"/>
            <p:nvPr/>
          </p:nvSpPr>
          <p:spPr>
            <a:xfrm>
              <a:off x="4911296" y="8072142"/>
              <a:ext cx="711139" cy="442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dirty="0"/>
                <a:t>37%</a:t>
              </a:r>
            </a:p>
          </p:txBody>
        </p:sp>
        <p:sp>
          <p:nvSpPr>
            <p:cNvPr id="18" name="CaixaDeTexto 17">
              <a:extLst>
                <a:ext uri="{FF2B5EF4-FFF2-40B4-BE49-F238E27FC236}">
                  <a16:creationId xmlns:a16="http://schemas.microsoft.com/office/drawing/2014/main" id="{D2567901-BC7B-E6C8-E7C1-2EF33AAB8DA3}"/>
                </a:ext>
              </a:extLst>
            </p:cNvPr>
            <p:cNvSpPr txBox="1"/>
            <p:nvPr/>
          </p:nvSpPr>
          <p:spPr>
            <a:xfrm>
              <a:off x="2421812" y="5882448"/>
              <a:ext cx="1252865" cy="4054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1600" dirty="0" err="1"/>
                <a:t>Unstained</a:t>
              </a:r>
              <a:endParaRPr lang="pt-PT" sz="1600" dirty="0"/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831FE5A4-E7F1-930D-8EE2-0FB8534B2BBB}"/>
                </a:ext>
              </a:extLst>
            </p:cNvPr>
            <p:cNvSpPr txBox="1"/>
            <p:nvPr/>
          </p:nvSpPr>
          <p:spPr>
            <a:xfrm>
              <a:off x="4911296" y="8605318"/>
              <a:ext cx="711139" cy="442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dirty="0"/>
                <a:t>42%</a:t>
              </a:r>
            </a:p>
          </p:txBody>
        </p:sp>
        <p:sp>
          <p:nvSpPr>
            <p:cNvPr id="20" name="CaixaDeTexto 19">
              <a:extLst>
                <a:ext uri="{FF2B5EF4-FFF2-40B4-BE49-F238E27FC236}">
                  <a16:creationId xmlns:a16="http://schemas.microsoft.com/office/drawing/2014/main" id="{C84AD6C8-AC50-66A3-11BC-208B6D01EC58}"/>
                </a:ext>
              </a:extLst>
            </p:cNvPr>
            <p:cNvSpPr txBox="1"/>
            <p:nvPr/>
          </p:nvSpPr>
          <p:spPr>
            <a:xfrm>
              <a:off x="847784" y="6425905"/>
              <a:ext cx="99674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800" dirty="0" err="1">
                  <a:latin typeface="+mj-lt"/>
                  <a:cs typeface="Aptos Serif" panose="020B0502040204020203" pitchFamily="18" charset="0"/>
                </a:rPr>
                <a:t>Day</a:t>
              </a:r>
              <a:r>
                <a:rPr lang="pt-PT" dirty="0"/>
                <a:t> 1 </a:t>
              </a: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7AA51319-1B3A-F790-165C-A11AB1C32F85}"/>
                </a:ext>
              </a:extLst>
            </p:cNvPr>
            <p:cNvSpPr txBox="1"/>
            <p:nvPr/>
          </p:nvSpPr>
          <p:spPr>
            <a:xfrm>
              <a:off x="850383" y="7003000"/>
              <a:ext cx="996746" cy="411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800" dirty="0" err="1"/>
                <a:t>Day</a:t>
              </a:r>
              <a:r>
                <a:rPr lang="pt-PT" sz="1800" dirty="0"/>
                <a:t> 5</a:t>
              </a:r>
              <a:endParaRPr lang="pt-PT" dirty="0"/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9B8553F1-4E6B-8A01-1092-4EE580FDA066}"/>
                </a:ext>
              </a:extLst>
            </p:cNvPr>
            <p:cNvSpPr txBox="1"/>
            <p:nvPr/>
          </p:nvSpPr>
          <p:spPr>
            <a:xfrm>
              <a:off x="873723" y="7544268"/>
              <a:ext cx="996746" cy="411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800" dirty="0" err="1"/>
                <a:t>Day</a:t>
              </a:r>
              <a:r>
                <a:rPr lang="pt-PT" sz="1800" dirty="0"/>
                <a:t> 3</a:t>
              </a:r>
              <a:endParaRPr lang="pt-PT" dirty="0"/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024DF129-A791-519C-3BCC-031D1F30B4A9}"/>
                </a:ext>
              </a:extLst>
            </p:cNvPr>
            <p:cNvSpPr txBox="1"/>
            <p:nvPr/>
          </p:nvSpPr>
          <p:spPr>
            <a:xfrm>
              <a:off x="879774" y="8205682"/>
              <a:ext cx="996746" cy="411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800" dirty="0" err="1"/>
                <a:t>Day</a:t>
              </a:r>
              <a:r>
                <a:rPr lang="pt-PT" sz="1800" dirty="0"/>
                <a:t> 5</a:t>
              </a:r>
              <a:endParaRPr lang="pt-PT" dirty="0"/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29572B18-3208-E950-8512-FD946E72217E}"/>
                </a:ext>
              </a:extLst>
            </p:cNvPr>
            <p:cNvSpPr txBox="1"/>
            <p:nvPr/>
          </p:nvSpPr>
          <p:spPr>
            <a:xfrm>
              <a:off x="866204" y="8745610"/>
              <a:ext cx="996746" cy="411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800" dirty="0" err="1"/>
                <a:t>Day</a:t>
              </a:r>
              <a:r>
                <a:rPr lang="pt-PT" sz="1800" dirty="0"/>
                <a:t> 5</a:t>
              </a:r>
              <a:endParaRPr lang="pt-PT" dirty="0"/>
            </a:p>
          </p:txBody>
        </p:sp>
      </p:grp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4DBF7585-A50F-57D6-A0C3-63EB043C5805}"/>
              </a:ext>
            </a:extLst>
          </p:cNvPr>
          <p:cNvSpPr txBox="1"/>
          <p:nvPr/>
        </p:nvSpPr>
        <p:spPr>
          <a:xfrm>
            <a:off x="169333" y="5731243"/>
            <a:ext cx="65193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genic mixed leukocyt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tion using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DCs as stimulator cells and PBM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as responder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histograms from PMBCs proliferation assessment of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respons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PMBC cultured with 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C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PBMC cell fraction was stained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arboxyfluorescein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ccinimidyl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ester (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FS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cultured alone (Day 5 PBMCs), stimulated for 3 days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horbol 12-myristate 13-acetat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MA)/Ionomycin (Day 3 PBMCs+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MA+I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or cultured in a ratio 5:1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BMCs: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C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unstimulated (Day 5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BMCs+DC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sialidase treate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C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ay 5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C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alidas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5 days. The percentage of proliferativ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BMC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s assessed by flow cytometry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 reference, CFSE staining intensity for the parental cells was assessed the day after labeling  (Day1) 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ults represent the mea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roliferation from cells in 2 replicates.</a:t>
            </a:r>
            <a:endParaRPr lang="pt-P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0291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4501042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p12"/>
          <p:cNvSpPr txBox="1"/>
          <p:nvPr/>
        </p:nvSpPr>
        <p:spPr>
          <a:xfrm>
            <a:off x="212652" y="5782166"/>
            <a:ext cx="6138529" cy="4501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1427" tIns="25706" rIns="51427" bIns="25706" anchor="t" anchorCtr="0">
            <a:spAutoFit/>
          </a:bodyPr>
          <a:lstStyle/>
          <a:p>
            <a:pPr>
              <a:buSzPts val="1400"/>
            </a:pPr>
            <a:r>
              <a:rPr lang="pt-PT" sz="750" b="1" dirty="0">
                <a:latin typeface="Times New Roman"/>
                <a:ea typeface="Times New Roman"/>
                <a:cs typeface="Times New Roman"/>
                <a:sym typeface="Times New Roman"/>
              </a:rPr>
              <a:t> Fig. </a:t>
            </a:r>
            <a:r>
              <a:rPr lang="pt-PT" sz="750" b="1">
                <a:latin typeface="Times New Roman"/>
                <a:ea typeface="Times New Roman"/>
                <a:cs typeface="Times New Roman"/>
                <a:sym typeface="Times New Roman"/>
              </a:rPr>
              <a:t>S4-Comparison </a:t>
            </a:r>
            <a:r>
              <a:rPr lang="pt-PT" sz="750" b="1" dirty="0" err="1"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pt-PT" sz="750" b="1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latin typeface="Times New Roman"/>
                <a:ea typeface="Times New Roman"/>
                <a:cs typeface="Times New Roman"/>
                <a:sym typeface="Times New Roman"/>
              </a:rPr>
              <a:t>the</a:t>
            </a:r>
            <a:r>
              <a:rPr lang="pt-PT" sz="750" b="1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latin typeface="Times New Roman"/>
                <a:ea typeface="Times New Roman"/>
                <a:cs typeface="Times New Roman"/>
                <a:sym typeface="Times New Roman"/>
              </a:rPr>
              <a:t>effects</a:t>
            </a:r>
            <a:r>
              <a:rPr lang="pt-PT" sz="750" b="1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pt-PT" sz="750" b="1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ialidase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reatment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nd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ytokine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aturation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n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ytokine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75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xpression</a:t>
            </a:r>
            <a:r>
              <a:rPr lang="pt-PT" sz="75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 </a:t>
            </a:r>
            <a:r>
              <a:rPr lang="pt-PT" sz="9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mRNA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expression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levels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 in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MoDCs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 3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and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 6h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after</a:t>
            </a:r>
            <a:r>
              <a:rPr lang="pt-PT" sz="900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pt-PT" sz="900" dirty="0" err="1">
                <a:latin typeface="Times New Roman"/>
                <a:ea typeface="Times New Roman"/>
                <a:cs typeface="Times New Roman"/>
                <a:sym typeface="Times New Roman"/>
              </a:rPr>
              <a:t>treatments</a:t>
            </a:r>
            <a:endParaRPr lang="pt-PT" sz="900" dirty="0" err="1">
              <a:highlight>
                <a:srgbClr val="FFFF00"/>
              </a:highlight>
              <a:latin typeface="Times New Roman"/>
              <a:cs typeface="Times New Roman"/>
            </a:endParaRPr>
          </a:p>
          <a:p>
            <a:pPr>
              <a:buSzPts val="1400"/>
            </a:pPr>
            <a:endParaRPr sz="788" dirty="0"/>
          </a:p>
        </p:txBody>
      </p:sp>
      <p:graphicFrame>
        <p:nvGraphicFramePr>
          <p:cNvPr id="260" name="Google Shape;260;p12"/>
          <p:cNvGraphicFramePr/>
          <p:nvPr/>
        </p:nvGraphicFramePr>
        <p:xfrm>
          <a:off x="1454025" y="3936173"/>
          <a:ext cx="1334366" cy="1530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2372205" imgH="2720497" progId="Prism8.Document">
                  <p:embed/>
                </p:oleObj>
              </mc:Choice>
              <mc:Fallback>
                <p:oleObj r:id="rId3" imgW="2372205" imgH="2720497" progId="Prism8.Document">
                  <p:embed/>
                  <p:pic>
                    <p:nvPicPr>
                      <p:cNvPr id="260" name="Google Shape;260;p12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1454025" y="3936173"/>
                        <a:ext cx="1334366" cy="15302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1" name="Google Shape;261;p12"/>
          <p:cNvGraphicFramePr/>
          <p:nvPr/>
        </p:nvGraphicFramePr>
        <p:xfrm>
          <a:off x="39881" y="3936173"/>
          <a:ext cx="1354851" cy="14293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2408624" imgH="2541026" progId="Prism8.Document">
                  <p:embed/>
                </p:oleObj>
              </mc:Choice>
              <mc:Fallback>
                <p:oleObj r:id="rId5" imgW="2408624" imgH="2541026" progId="Prism8.Document">
                  <p:embed/>
                  <p:pic>
                    <p:nvPicPr>
                      <p:cNvPr id="261" name="Google Shape;261;p12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39881" y="3936173"/>
                        <a:ext cx="1354851" cy="142932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2" name="Google Shape;262;p12"/>
          <p:cNvGraphicFramePr/>
          <p:nvPr/>
        </p:nvGraphicFramePr>
        <p:xfrm>
          <a:off x="2788391" y="3929596"/>
          <a:ext cx="1440044" cy="1587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2560077" imgH="2822253" progId="Prism8.Document">
                  <p:embed/>
                </p:oleObj>
              </mc:Choice>
              <mc:Fallback>
                <p:oleObj r:id="rId7" imgW="2560077" imgH="2822253" progId="Prism8.Document">
                  <p:embed/>
                  <p:pic>
                    <p:nvPicPr>
                      <p:cNvPr id="262" name="Google Shape;262;p12"/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/>
                      <a:stretch/>
                    </p:blipFill>
                    <p:spPr>
                      <a:xfrm>
                        <a:off x="2788391" y="3929596"/>
                        <a:ext cx="1440044" cy="158751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3" name="Google Shape;263;p12"/>
          <p:cNvGraphicFramePr/>
          <p:nvPr>
            <p:extLst>
              <p:ext uri="{D42A27DB-BD31-4B8C-83A1-F6EECF244321}">
                <p14:modId xmlns:p14="http://schemas.microsoft.com/office/powerpoint/2010/main" val="3093650365"/>
              </p:ext>
            </p:extLst>
          </p:nvPr>
        </p:nvGraphicFramePr>
        <p:xfrm>
          <a:off x="5512948" y="3944617"/>
          <a:ext cx="1343319" cy="15579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2388123" imgH="2769746" progId="Prism8.Document">
                  <p:embed/>
                </p:oleObj>
              </mc:Choice>
              <mc:Fallback>
                <p:oleObj r:id="rId9" imgW="2388123" imgH="2769746" progId="Prism8.Document">
                  <p:embed/>
                  <p:pic>
                    <p:nvPicPr>
                      <p:cNvPr id="263" name="Google Shape;263;p12"/>
                      <p:cNvPicPr preferRelativeResize="0"/>
                      <p:nvPr/>
                    </p:nvPicPr>
                    <p:blipFill rotWithShape="1">
                      <a:blip r:embed="rId10">
                        <a:alphaModFix/>
                      </a:blip>
                      <a:srcRect/>
                      <a:stretch/>
                    </p:blipFill>
                    <p:spPr>
                      <a:xfrm>
                        <a:off x="5512948" y="3944617"/>
                        <a:ext cx="1343319" cy="15579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4" name="Google Shape;264;p12"/>
          <p:cNvGraphicFramePr/>
          <p:nvPr>
            <p:extLst>
              <p:ext uri="{D42A27DB-BD31-4B8C-83A1-F6EECF244321}">
                <p14:modId xmlns:p14="http://schemas.microsoft.com/office/powerpoint/2010/main" val="3101297027"/>
              </p:ext>
            </p:extLst>
          </p:nvPr>
        </p:nvGraphicFramePr>
        <p:xfrm>
          <a:off x="4167162" y="3943133"/>
          <a:ext cx="1344462" cy="15174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2390154" imgH="2697610" progId="Prism8.Document">
                  <p:embed/>
                </p:oleObj>
              </mc:Choice>
              <mc:Fallback>
                <p:oleObj r:id="rId11" imgW="2390154" imgH="2697610" progId="Prism8.Document">
                  <p:embed/>
                  <p:pic>
                    <p:nvPicPr>
                      <p:cNvPr id="264" name="Google Shape;264;p12"/>
                      <p:cNvPicPr preferRelativeResize="0"/>
                      <p:nvPr/>
                    </p:nvPicPr>
                    <p:blipFill rotWithShape="1">
                      <a:blip r:embed="rId12">
                        <a:alphaModFix/>
                      </a:blip>
                      <a:srcRect/>
                      <a:stretch/>
                    </p:blipFill>
                    <p:spPr>
                      <a:xfrm>
                        <a:off x="4167162" y="3943133"/>
                        <a:ext cx="1344462" cy="151740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587</Words>
  <Application>Microsoft Office PowerPoint</Application>
  <PresentationFormat>Papel A4 (210x297 mm)</PresentationFormat>
  <Paragraphs>23</Paragraphs>
  <Slides>5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5</vt:i4>
      </vt:variant>
    </vt:vector>
  </HeadingPairs>
  <TitlesOfParts>
    <vt:vector size="6" baseType="lpstr"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Zélia Silva</dc:creator>
  <cp:lastModifiedBy>Zelia Maria Cordeiro da Silva</cp:lastModifiedBy>
  <cp:revision>155</cp:revision>
  <dcterms:created xsi:type="dcterms:W3CDTF">2021-12-15T11:17:37Z</dcterms:created>
  <dcterms:modified xsi:type="dcterms:W3CDTF">2024-09-11T15:31:27Z</dcterms:modified>
</cp:coreProperties>
</file>